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81F1"/>
    <a:srgbClr val="CCFF99"/>
    <a:srgbClr val="99FF66"/>
    <a:srgbClr val="FFFF99"/>
    <a:srgbClr val="F6A8ED"/>
    <a:srgbClr val="08028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15" autoAdjust="0"/>
    <p:restoredTop sz="91029" autoAdjust="0"/>
  </p:normalViewPr>
  <p:slideViewPr>
    <p:cSldViewPr showGuides="1">
      <p:cViewPr>
        <p:scale>
          <a:sx n="70" d="100"/>
          <a:sy n="70" d="100"/>
        </p:scale>
        <p:origin x="-2220" y="-36"/>
      </p:cViewPr>
      <p:guideLst>
        <p:guide orient="horz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00968758759842E-2"/>
          <c:y val="0.161954306609877"/>
          <c:w val="0.87955127415803902"/>
          <c:h val="0.7405654570124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2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03:$A$131</c:f>
              <c:numCache>
                <c:formatCode>General</c:formatCode>
                <c:ptCount val="29"/>
              </c:numCache>
            </c:numRef>
          </c:cat>
          <c:val>
            <c:numRef>
              <c:f>Sheet1!$B$103:$B$131</c:f>
              <c:numCache>
                <c:formatCode>General</c:formatCode>
                <c:ptCount val="29"/>
                <c:pt idx="0">
                  <c:v>0.73073626768649602</c:v>
                </c:pt>
                <c:pt idx="1">
                  <c:v>0.91450864782900998</c:v>
                </c:pt>
                <c:pt idx="2">
                  <c:v>0.97145812715112001</c:v>
                </c:pt>
                <c:pt idx="3">
                  <c:v>0.446026618800274</c:v>
                </c:pt>
                <c:pt idx="4">
                  <c:v>1.68780498277243</c:v>
                </c:pt>
                <c:pt idx="5">
                  <c:v>0.232277886568413</c:v>
                </c:pt>
                <c:pt idx="6">
                  <c:v>2.928158640916779</c:v>
                </c:pt>
                <c:pt idx="7">
                  <c:v>0.66341715221154496</c:v>
                </c:pt>
                <c:pt idx="8">
                  <c:v>0.31533226881981602</c:v>
                </c:pt>
                <c:pt idx="9">
                  <c:v>2.0620884521542182</c:v>
                </c:pt>
                <c:pt idx="10">
                  <c:v>1.310833744681102</c:v>
                </c:pt>
                <c:pt idx="13">
                  <c:v>0.22541246746268401</c:v>
                </c:pt>
                <c:pt idx="14">
                  <c:v>0.269951982631293</c:v>
                </c:pt>
                <c:pt idx="15">
                  <c:v>0.174503843494418</c:v>
                </c:pt>
                <c:pt idx="16">
                  <c:v>0.40938814128622197</c:v>
                </c:pt>
                <c:pt idx="17">
                  <c:v>0.57148328898898904</c:v>
                </c:pt>
                <c:pt idx="18">
                  <c:v>0.21525597925710199</c:v>
                </c:pt>
                <c:pt idx="19">
                  <c:v>8.6296790673077203E-2</c:v>
                </c:pt>
                <c:pt idx="20">
                  <c:v>0.25786381014565202</c:v>
                </c:pt>
                <c:pt idx="21">
                  <c:v>0.45283573540415301</c:v>
                </c:pt>
                <c:pt idx="22">
                  <c:v>0.498176791514992</c:v>
                </c:pt>
                <c:pt idx="25">
                  <c:v>0.31973447568795299</c:v>
                </c:pt>
                <c:pt idx="26">
                  <c:v>0.33391937667265997</c:v>
                </c:pt>
                <c:pt idx="27">
                  <c:v>0.944227049347657</c:v>
                </c:pt>
                <c:pt idx="28">
                  <c:v>0.33426256963072698</c:v>
                </c:pt>
              </c:numCache>
            </c:numRef>
          </c:val>
        </c:ser>
        <c:ser>
          <c:idx val="1"/>
          <c:order val="1"/>
          <c:tx>
            <c:strRef>
              <c:f>Sheet1!$C$102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03:$A$131</c:f>
              <c:numCache>
                <c:formatCode>General</c:formatCode>
                <c:ptCount val="29"/>
              </c:numCache>
            </c:numRef>
          </c:cat>
          <c:val>
            <c:numRef>
              <c:f>Sheet1!$C$103:$C$131</c:f>
              <c:numCache>
                <c:formatCode>General</c:formatCode>
                <c:ptCount val="29"/>
                <c:pt idx="0">
                  <c:v>0.31449788446128901</c:v>
                </c:pt>
                <c:pt idx="1">
                  <c:v>0.24200339931346601</c:v>
                </c:pt>
                <c:pt idx="2">
                  <c:v>0.86744681909918597</c:v>
                </c:pt>
                <c:pt idx="3">
                  <c:v>0.30985114779003398</c:v>
                </c:pt>
                <c:pt idx="4">
                  <c:v>0.445321205572138</c:v>
                </c:pt>
                <c:pt idx="5">
                  <c:v>0.707688665292451</c:v>
                </c:pt>
                <c:pt idx="6">
                  <c:v>0.75359626390347301</c:v>
                </c:pt>
                <c:pt idx="7">
                  <c:v>0.19807932625897301</c:v>
                </c:pt>
                <c:pt idx="8">
                  <c:v>0.38400266211693501</c:v>
                </c:pt>
                <c:pt idx="9">
                  <c:v>1.4356884549551321</c:v>
                </c:pt>
                <c:pt idx="10">
                  <c:v>1.3242327518608541</c:v>
                </c:pt>
                <c:pt idx="13">
                  <c:v>0.45627696212836399</c:v>
                </c:pt>
                <c:pt idx="14">
                  <c:v>0.23997486614139901</c:v>
                </c:pt>
                <c:pt idx="15">
                  <c:v>0.79705032226449302</c:v>
                </c:pt>
                <c:pt idx="16">
                  <c:v>0.89450082478635295</c:v>
                </c:pt>
                <c:pt idx="17">
                  <c:v>0.87148740397192503</c:v>
                </c:pt>
                <c:pt idx="18">
                  <c:v>0.46738820039279</c:v>
                </c:pt>
                <c:pt idx="19">
                  <c:v>0.496976389189007</c:v>
                </c:pt>
                <c:pt idx="20">
                  <c:v>0.55406771788589604</c:v>
                </c:pt>
                <c:pt idx="21">
                  <c:v>2.0144642708645581</c:v>
                </c:pt>
                <c:pt idx="22">
                  <c:v>1.496596408046041</c:v>
                </c:pt>
                <c:pt idx="25">
                  <c:v>0.88298951851576302</c:v>
                </c:pt>
                <c:pt idx="26">
                  <c:v>0.20546388260082499</c:v>
                </c:pt>
                <c:pt idx="27">
                  <c:v>0.46185046240564798</c:v>
                </c:pt>
                <c:pt idx="28">
                  <c:v>0.998453550194608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50720"/>
        <c:axId val="9952256"/>
      </c:barChart>
      <c:catAx>
        <c:axId val="995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zh-CN"/>
          </a:p>
        </c:txPr>
        <c:crossAx val="9952256"/>
        <c:crosses val="autoZero"/>
        <c:auto val="1"/>
        <c:lblAlgn val="ctr"/>
        <c:lblOffset val="100"/>
        <c:noMultiLvlLbl val="0"/>
      </c:catAx>
      <c:valAx>
        <c:axId val="995225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ja-JP" sz="10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9950720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206979440069991"/>
          <c:y val="5.3862092088788303E-3"/>
          <c:w val="0.63487787984835298"/>
          <c:h val="0.18742490000807199"/>
        </c:manualLayout>
      </c:layout>
      <c:overlay val="0"/>
      <c:txPr>
        <a:bodyPr/>
        <a:lstStyle/>
        <a:p>
          <a:pPr>
            <a:defRPr lang="ja-JP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168455024859796E-2"/>
          <c:y val="0.150822371006019"/>
          <c:w val="0.86603004166173903"/>
          <c:h val="0.754692714308915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1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02:$A$130</c:f>
              <c:numCache>
                <c:formatCode>General</c:formatCode>
                <c:ptCount val="29"/>
              </c:numCache>
            </c:numRef>
          </c:cat>
          <c:val>
            <c:numRef>
              <c:f>Sheet1!$B$102:$B$130</c:f>
              <c:numCache>
                <c:formatCode>General</c:formatCode>
                <c:ptCount val="29"/>
                <c:pt idx="0">
                  <c:v>2.820024284886351</c:v>
                </c:pt>
                <c:pt idx="1">
                  <c:v>0.25748835394184999</c:v>
                </c:pt>
                <c:pt idx="2">
                  <c:v>1.314826178824706</c:v>
                </c:pt>
                <c:pt idx="3">
                  <c:v>7.4239273198658164</c:v>
                </c:pt>
                <c:pt idx="4">
                  <c:v>0.71335399681854506</c:v>
                </c:pt>
                <c:pt idx="5">
                  <c:v>3.3671467201525931</c:v>
                </c:pt>
                <c:pt idx="6">
                  <c:v>3.962895945177717</c:v>
                </c:pt>
                <c:pt idx="7">
                  <c:v>1.3625848644652201</c:v>
                </c:pt>
                <c:pt idx="8">
                  <c:v>1.8245814901732449</c:v>
                </c:pt>
                <c:pt idx="9">
                  <c:v>0.16665841695149</c:v>
                </c:pt>
                <c:pt idx="10">
                  <c:v>0.35587489972521003</c:v>
                </c:pt>
                <c:pt idx="13">
                  <c:v>3.6157341006978871</c:v>
                </c:pt>
                <c:pt idx="14">
                  <c:v>0.76193751049953096</c:v>
                </c:pt>
                <c:pt idx="15">
                  <c:v>0.67430681634133105</c:v>
                </c:pt>
                <c:pt idx="16">
                  <c:v>5.1431548342984872</c:v>
                </c:pt>
                <c:pt idx="17">
                  <c:v>0.71316464403754998</c:v>
                </c:pt>
                <c:pt idx="18">
                  <c:v>5.5483857209494651</c:v>
                </c:pt>
                <c:pt idx="19">
                  <c:v>9.1939835608647975</c:v>
                </c:pt>
                <c:pt idx="20">
                  <c:v>5.7757151269650766</c:v>
                </c:pt>
                <c:pt idx="21">
                  <c:v>3.5053089034853468</c:v>
                </c:pt>
                <c:pt idx="22">
                  <c:v>1.849066468827463</c:v>
                </c:pt>
                <c:pt idx="25">
                  <c:v>1.9011041709308769</c:v>
                </c:pt>
                <c:pt idx="26">
                  <c:v>0.84825876451607396</c:v>
                </c:pt>
                <c:pt idx="27">
                  <c:v>4.541889435606457</c:v>
                </c:pt>
                <c:pt idx="28">
                  <c:v>4.8481995694069786</c:v>
                </c:pt>
              </c:numCache>
            </c:numRef>
          </c:val>
        </c:ser>
        <c:ser>
          <c:idx val="1"/>
          <c:order val="1"/>
          <c:tx>
            <c:strRef>
              <c:f>Sheet1!$C$101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02:$A$130</c:f>
              <c:numCache>
                <c:formatCode>General</c:formatCode>
                <c:ptCount val="29"/>
              </c:numCache>
            </c:numRef>
          </c:cat>
          <c:val>
            <c:numRef>
              <c:f>Sheet1!$C$102:$C$130</c:f>
              <c:numCache>
                <c:formatCode>General</c:formatCode>
                <c:ptCount val="29"/>
                <c:pt idx="0">
                  <c:v>4.6556999628102842</c:v>
                </c:pt>
                <c:pt idx="1">
                  <c:v>2.4400726225499381</c:v>
                </c:pt>
                <c:pt idx="2">
                  <c:v>4.3304384009194896</c:v>
                </c:pt>
                <c:pt idx="3">
                  <c:v>7.0524967040396476</c:v>
                </c:pt>
                <c:pt idx="4">
                  <c:v>2.135512120918162</c:v>
                </c:pt>
                <c:pt idx="5">
                  <c:v>6.5594487926944796</c:v>
                </c:pt>
                <c:pt idx="6">
                  <c:v>9.8607958330738494</c:v>
                </c:pt>
                <c:pt idx="7">
                  <c:v>2.7768949222251589</c:v>
                </c:pt>
                <c:pt idx="8">
                  <c:v>2.3758324327473082</c:v>
                </c:pt>
                <c:pt idx="9">
                  <c:v>0.435981277287457</c:v>
                </c:pt>
                <c:pt idx="10">
                  <c:v>1.848479554747714</c:v>
                </c:pt>
                <c:pt idx="13">
                  <c:v>0.81895216213730204</c:v>
                </c:pt>
                <c:pt idx="14">
                  <c:v>0.72682355805616095</c:v>
                </c:pt>
                <c:pt idx="15">
                  <c:v>0.72969834490681196</c:v>
                </c:pt>
                <c:pt idx="16">
                  <c:v>6.4512292562578812</c:v>
                </c:pt>
                <c:pt idx="17">
                  <c:v>0.27456070862385901</c:v>
                </c:pt>
                <c:pt idx="18">
                  <c:v>1.013058921507771</c:v>
                </c:pt>
                <c:pt idx="19">
                  <c:v>9.0912179589790352</c:v>
                </c:pt>
                <c:pt idx="20">
                  <c:v>4.0322975078501413</c:v>
                </c:pt>
                <c:pt idx="21">
                  <c:v>4.7630760592155337</c:v>
                </c:pt>
                <c:pt idx="22">
                  <c:v>4.0590682178263622</c:v>
                </c:pt>
                <c:pt idx="25">
                  <c:v>1.79838148363061</c:v>
                </c:pt>
                <c:pt idx="26">
                  <c:v>0.24123699703257601</c:v>
                </c:pt>
                <c:pt idx="27">
                  <c:v>4.4889361838078523</c:v>
                </c:pt>
                <c:pt idx="28">
                  <c:v>4.37006908369697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53024"/>
        <c:axId val="13558912"/>
      </c:barChart>
      <c:catAx>
        <c:axId val="13553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zh-CN"/>
          </a:p>
        </c:txPr>
        <c:crossAx val="13558912"/>
        <c:crosses val="autoZero"/>
        <c:auto val="1"/>
        <c:lblAlgn val="ctr"/>
        <c:lblOffset val="100"/>
        <c:noMultiLvlLbl val="0"/>
      </c:catAx>
      <c:valAx>
        <c:axId val="1355891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ja-JP" sz="10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13553024"/>
        <c:crosses val="autoZero"/>
        <c:crossBetween val="between"/>
        <c:majorUnit val="3"/>
      </c:valAx>
    </c:plotArea>
    <c:legend>
      <c:legendPos val="r"/>
      <c:layout>
        <c:manualLayout>
          <c:xMode val="edge"/>
          <c:yMode val="edge"/>
          <c:x val="0.17079542140565801"/>
          <c:y val="8.3166999334664104E-3"/>
          <c:w val="0.74352435112277704"/>
          <c:h val="0.200296949488457"/>
        </c:manualLayout>
      </c:layout>
      <c:overlay val="0"/>
      <c:txPr>
        <a:bodyPr/>
        <a:lstStyle/>
        <a:p>
          <a:pPr>
            <a:defRPr lang="ja-JP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8168455024859796E-2"/>
          <c:y val="0.137287105578869"/>
          <c:w val="0.86121402508716205"/>
          <c:h val="0.772023538225387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B$4:$B$32</c:f>
              <c:numCache>
                <c:formatCode>General</c:formatCode>
                <c:ptCount val="29"/>
                <c:pt idx="0">
                  <c:v>1.273973702323455</c:v>
                </c:pt>
                <c:pt idx="1">
                  <c:v>1.232320481823538</c:v>
                </c:pt>
                <c:pt idx="2">
                  <c:v>0.56375256494908699</c:v>
                </c:pt>
                <c:pt idx="3">
                  <c:v>0.81430772708040999</c:v>
                </c:pt>
                <c:pt idx="4">
                  <c:v>1.5101794569790179</c:v>
                </c:pt>
                <c:pt idx="5">
                  <c:v>0.56377171268580095</c:v>
                </c:pt>
                <c:pt idx="6">
                  <c:v>0.53909446318532706</c:v>
                </c:pt>
                <c:pt idx="7">
                  <c:v>0.63150387749408798</c:v>
                </c:pt>
                <c:pt idx="8">
                  <c:v>0.84075974303068701</c:v>
                </c:pt>
                <c:pt idx="9">
                  <c:v>0.68434228459588298</c:v>
                </c:pt>
                <c:pt idx="10">
                  <c:v>0.47366582734123902</c:v>
                </c:pt>
                <c:pt idx="13">
                  <c:v>1.0847600838754761</c:v>
                </c:pt>
                <c:pt idx="14">
                  <c:v>0.58879853929379999</c:v>
                </c:pt>
                <c:pt idx="15">
                  <c:v>0.81200667802285897</c:v>
                </c:pt>
                <c:pt idx="16">
                  <c:v>1.175903358613644</c:v>
                </c:pt>
                <c:pt idx="17">
                  <c:v>0.176812968254939</c:v>
                </c:pt>
                <c:pt idx="18">
                  <c:v>0.39954641019839798</c:v>
                </c:pt>
                <c:pt idx="19">
                  <c:v>0.58064367471254297</c:v>
                </c:pt>
                <c:pt idx="20">
                  <c:v>0.254116242567682</c:v>
                </c:pt>
                <c:pt idx="21">
                  <c:v>0.73978117666366305</c:v>
                </c:pt>
                <c:pt idx="22">
                  <c:v>0.34006866844840999</c:v>
                </c:pt>
                <c:pt idx="25">
                  <c:v>0.52031492548965097</c:v>
                </c:pt>
                <c:pt idx="26">
                  <c:v>0.45209378734203698</c:v>
                </c:pt>
                <c:pt idx="27">
                  <c:v>0.329121914768711</c:v>
                </c:pt>
                <c:pt idx="28">
                  <c:v>1.240706176444808</c:v>
                </c:pt>
              </c:numCache>
            </c:numRef>
          </c:val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C$4:$C$32</c:f>
              <c:numCache>
                <c:formatCode>General</c:formatCode>
                <c:ptCount val="29"/>
                <c:pt idx="0">
                  <c:v>0.86545157154317498</c:v>
                </c:pt>
                <c:pt idx="1">
                  <c:v>0.46383336210465298</c:v>
                </c:pt>
                <c:pt idx="2">
                  <c:v>1.9438982253093401E-2</c:v>
                </c:pt>
                <c:pt idx="3">
                  <c:v>0.57911087627639601</c:v>
                </c:pt>
                <c:pt idx="4">
                  <c:v>0.149919089092029</c:v>
                </c:pt>
                <c:pt idx="5">
                  <c:v>2.66397803508573E-2</c:v>
                </c:pt>
                <c:pt idx="6">
                  <c:v>0.13761417588560501</c:v>
                </c:pt>
                <c:pt idx="7">
                  <c:v>0.17456769375238301</c:v>
                </c:pt>
                <c:pt idx="8">
                  <c:v>4.0791333966616002E-2</c:v>
                </c:pt>
                <c:pt idx="9">
                  <c:v>0.12290589314410801</c:v>
                </c:pt>
                <c:pt idx="10">
                  <c:v>0.37277460798189399</c:v>
                </c:pt>
                <c:pt idx="13">
                  <c:v>1.3991551965497111</c:v>
                </c:pt>
                <c:pt idx="14">
                  <c:v>0.28549987072354699</c:v>
                </c:pt>
                <c:pt idx="15">
                  <c:v>1.286100601242363</c:v>
                </c:pt>
                <c:pt idx="16">
                  <c:v>0.205692200782119</c:v>
                </c:pt>
                <c:pt idx="17">
                  <c:v>7.6273171382845006E-2</c:v>
                </c:pt>
                <c:pt idx="18">
                  <c:v>0.29045397869794598</c:v>
                </c:pt>
                <c:pt idx="19">
                  <c:v>0.440340973431814</c:v>
                </c:pt>
                <c:pt idx="20">
                  <c:v>0.22883704062426399</c:v>
                </c:pt>
                <c:pt idx="21">
                  <c:v>1.196252547837926</c:v>
                </c:pt>
                <c:pt idx="22">
                  <c:v>0.40411099152909702</c:v>
                </c:pt>
                <c:pt idx="25">
                  <c:v>0.57142893562624897</c:v>
                </c:pt>
                <c:pt idx="26">
                  <c:v>0.42359794556435698</c:v>
                </c:pt>
                <c:pt idx="27">
                  <c:v>0.198890944572988</c:v>
                </c:pt>
                <c:pt idx="28">
                  <c:v>0.35961011281414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5565184"/>
        <c:axId val="145566720"/>
      </c:barChart>
      <c:catAx>
        <c:axId val="145565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ja-JP"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45566720"/>
        <c:crossesAt val="1E-3"/>
        <c:auto val="1"/>
        <c:lblAlgn val="ctr"/>
        <c:lblOffset val="100"/>
        <c:noMultiLvlLbl val="0"/>
      </c:catAx>
      <c:valAx>
        <c:axId val="14556672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ja-JP" sz="10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145565184"/>
        <c:crosses val="autoZero"/>
        <c:crossBetween val="between"/>
        <c:majorUnit val="0.5"/>
      </c:valAx>
    </c:plotArea>
    <c:legend>
      <c:legendPos val="r"/>
      <c:legendEntry>
        <c:idx val="0"/>
        <c:txPr>
          <a:bodyPr/>
          <a:lstStyle/>
          <a:p>
            <a:pPr>
              <a:defRPr sz="1000" b="1">
                <a:latin typeface="+mj-lt"/>
                <a:cs typeface="Times New Roman" pitchFamily="18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20886045494313199"/>
          <c:y val="5.73066465494209E-3"/>
          <c:w val="0.73420421405657699"/>
          <c:h val="0.19006375453810201"/>
        </c:manualLayout>
      </c:layout>
      <c:overlay val="0"/>
      <c:txPr>
        <a:bodyPr/>
        <a:lstStyle/>
        <a:p>
          <a:pPr>
            <a:defRPr lang="ja-JP" sz="1000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2C8972D8-9D7B-4723-9BA4-E13CCC482EB1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B25E521-CA0B-419A-A51A-3F8729EA0C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445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25E521-CA0B-419A-A51A-3F8729EA0C4F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960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376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36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374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949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181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626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001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31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48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22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903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65FA0-C695-4CEA-A096-3375F230C975}" type="datetimeFigureOut">
              <a:rPr lang="en-US" smtClean="0"/>
              <a:pPr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B6870-9F05-4FCC-A13D-CC1EAC525C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65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1790402"/>
              </p:ext>
            </p:extLst>
          </p:nvPr>
        </p:nvGraphicFramePr>
        <p:xfrm>
          <a:off x="3650192" y="1352140"/>
          <a:ext cx="2743200" cy="1527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3484121" y="826532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b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60" name="Chart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941985"/>
              </p:ext>
            </p:extLst>
          </p:nvPr>
        </p:nvGraphicFramePr>
        <p:xfrm>
          <a:off x="794924" y="3497306"/>
          <a:ext cx="2743200" cy="1527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61" name="Straight Connector 60"/>
          <p:cNvCxnSpPr/>
          <p:nvPr/>
        </p:nvCxnSpPr>
        <p:spPr>
          <a:xfrm>
            <a:off x="3124200" y="4975002"/>
            <a:ext cx="3233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2974580" y="4953000"/>
            <a:ext cx="8354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63" name="Straight Connector 62"/>
          <p:cNvCxnSpPr/>
          <p:nvPr/>
        </p:nvCxnSpPr>
        <p:spPr>
          <a:xfrm>
            <a:off x="2133600" y="4973777"/>
            <a:ext cx="7894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2226404" y="4953000"/>
            <a:ext cx="97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65" name="Straight Connector 64"/>
          <p:cNvCxnSpPr/>
          <p:nvPr/>
        </p:nvCxnSpPr>
        <p:spPr>
          <a:xfrm>
            <a:off x="1053138" y="4973777"/>
            <a:ext cx="9013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1119178" y="4953000"/>
            <a:ext cx="7858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17278" y="3048000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c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33400" y="457200"/>
            <a:ext cx="105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+mj-lt"/>
                <a:cs typeface="Times New Roman" pitchFamily="18" charset="0"/>
              </a:rPr>
              <a:t>Figure </a:t>
            </a:r>
            <a:r>
              <a:rPr lang="en-US" b="1" dirty="0" smtClean="0">
                <a:latin typeface="+mj-lt"/>
                <a:cs typeface="Times New Roman" pitchFamily="18" charset="0"/>
              </a:rPr>
              <a:t>S2</a:t>
            </a:r>
            <a:endParaRPr lang="en-US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>
            <a:off x="5943600" y="2816363"/>
            <a:ext cx="34440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5793980" y="2796238"/>
            <a:ext cx="8354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125" name="Straight Connector 124"/>
          <p:cNvCxnSpPr/>
          <p:nvPr/>
        </p:nvCxnSpPr>
        <p:spPr>
          <a:xfrm>
            <a:off x="4967938" y="2815138"/>
            <a:ext cx="7894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4984542" y="2796238"/>
            <a:ext cx="97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127" name="Straight Connector 126"/>
          <p:cNvCxnSpPr/>
          <p:nvPr/>
        </p:nvCxnSpPr>
        <p:spPr>
          <a:xfrm>
            <a:off x="3886200" y="2821087"/>
            <a:ext cx="90203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3977338" y="2796238"/>
            <a:ext cx="7858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151" name="Chart 1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8853007"/>
              </p:ext>
            </p:extLst>
          </p:nvPr>
        </p:nvGraphicFramePr>
        <p:xfrm>
          <a:off x="720774" y="1352140"/>
          <a:ext cx="2743200" cy="1527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53" name="Straight Connector 152"/>
          <p:cNvCxnSpPr/>
          <p:nvPr/>
        </p:nvCxnSpPr>
        <p:spPr>
          <a:xfrm>
            <a:off x="3084598" y="2820065"/>
            <a:ext cx="3286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2898380" y="2799940"/>
            <a:ext cx="8354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155" name="Straight Connector 154"/>
          <p:cNvCxnSpPr/>
          <p:nvPr/>
        </p:nvCxnSpPr>
        <p:spPr>
          <a:xfrm>
            <a:off x="2095234" y="2818840"/>
            <a:ext cx="7894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/>
          <p:cNvSpPr txBox="1"/>
          <p:nvPr/>
        </p:nvSpPr>
        <p:spPr>
          <a:xfrm>
            <a:off x="2111838" y="2799940"/>
            <a:ext cx="97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157" name="Straight Connector 156"/>
          <p:cNvCxnSpPr/>
          <p:nvPr/>
        </p:nvCxnSpPr>
        <p:spPr>
          <a:xfrm>
            <a:off x="990600" y="2824789"/>
            <a:ext cx="91630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/>
          <p:cNvSpPr txBox="1"/>
          <p:nvPr/>
        </p:nvSpPr>
        <p:spPr>
          <a:xfrm>
            <a:off x="1053138" y="2799940"/>
            <a:ext cx="7858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506058" y="826532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a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816509" y="1170801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DBH-AS1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714602" y="1170801"/>
            <a:ext cx="625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+mj-lt"/>
                <a:cs typeface="Times New Roman" pitchFamily="18" charset="0"/>
              </a:rPr>
              <a:t>hDREH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828800" y="3304401"/>
            <a:ext cx="595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hPVT1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98339" y="5715382"/>
            <a:ext cx="5573861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dirty="0">
                <a:latin typeface="Times New Roman"/>
                <a:cs typeface="Times New Roman"/>
              </a:rPr>
              <a:t>The </a:t>
            </a:r>
            <a:r>
              <a:rPr lang="en-US" dirty="0" err="1">
                <a:latin typeface="Times New Roman"/>
                <a:cs typeface="Times New Roman"/>
              </a:rPr>
              <a:t>lncRNAs</a:t>
            </a:r>
            <a:r>
              <a:rPr lang="en-US" dirty="0">
                <a:latin typeface="Times New Roman"/>
                <a:cs typeface="Times New Roman"/>
              </a:rPr>
              <a:t>, DBH-AS1, </a:t>
            </a:r>
            <a:r>
              <a:rPr lang="en-US" dirty="0" err="1">
                <a:latin typeface="Times New Roman"/>
                <a:cs typeface="Times New Roman"/>
              </a:rPr>
              <a:t>hDREH</a:t>
            </a:r>
            <a:r>
              <a:rPr lang="en-US" dirty="0">
                <a:latin typeface="Times New Roman"/>
                <a:cs typeface="Times New Roman"/>
              </a:rPr>
              <a:t> and hPVT1 were differentially </a:t>
            </a:r>
            <a:r>
              <a:rPr lang="en-US" dirty="0" err="1">
                <a:latin typeface="Times New Roman"/>
                <a:cs typeface="Times New Roman"/>
              </a:rPr>
              <a:t>dysregulated</a:t>
            </a:r>
            <a:r>
              <a:rPr lang="en-US" dirty="0">
                <a:latin typeface="Times New Roman"/>
                <a:cs typeface="Times New Roman"/>
              </a:rPr>
              <a:t> in HBV-, HCV-, and HDV-related HCC. The expression of </a:t>
            </a:r>
            <a:r>
              <a:rPr lang="en-US" dirty="0" err="1">
                <a:latin typeface="Times New Roman"/>
                <a:cs typeface="Times New Roman"/>
              </a:rPr>
              <a:t>lncRNAs</a:t>
            </a:r>
            <a:r>
              <a:rPr lang="en-US" dirty="0">
                <a:latin typeface="Times New Roman"/>
                <a:cs typeface="Times New Roman"/>
              </a:rPr>
              <a:t> in the tumor and surrounding non-tumorous tissue in a series of patients with HCC-associated with HBV, HCV and HDV was analyzed by </a:t>
            </a:r>
            <a:r>
              <a:rPr lang="en-US" dirty="0" err="1">
                <a:latin typeface="Times New Roman"/>
                <a:cs typeface="Times New Roman"/>
              </a:rPr>
              <a:t>qRT</a:t>
            </a:r>
            <a:r>
              <a:rPr lang="en-US" dirty="0">
                <a:latin typeface="Times New Roman"/>
                <a:cs typeface="Times New Roman"/>
              </a:rPr>
              <a:t>-PCR. The expression levels of </a:t>
            </a:r>
            <a:r>
              <a:rPr lang="en-US" dirty="0" err="1">
                <a:latin typeface="Times New Roman"/>
                <a:cs typeface="Times New Roman"/>
              </a:rPr>
              <a:t>lncRNAs</a:t>
            </a:r>
            <a:r>
              <a:rPr lang="en-US" dirty="0">
                <a:latin typeface="Times New Roman"/>
                <a:cs typeface="Times New Roman"/>
              </a:rPr>
              <a:t> was normalized to the house keeping gene GAPDH. </a:t>
            </a:r>
            <a:r>
              <a:rPr lang="en-US" dirty="0">
                <a:latin typeface="Times New Roman"/>
                <a:cs typeface="Times New Roman"/>
              </a:rPr>
              <a:t>Y axis indicate the relative expression of </a:t>
            </a:r>
            <a:r>
              <a:rPr lang="en-US" dirty="0" err="1">
                <a:latin typeface="Times New Roman"/>
                <a:cs typeface="Times New Roman"/>
              </a:rPr>
              <a:t>lncRNAs</a:t>
            </a:r>
            <a:r>
              <a:rPr lang="en-US" dirty="0">
                <a:latin typeface="Times New Roman"/>
                <a:cs typeface="Times New Roman"/>
              </a:rPr>
              <a:t>, which was calculated as described in the Materials and Methods. (</a:t>
            </a:r>
            <a:r>
              <a:rPr lang="en-US" b="1" dirty="0">
                <a:latin typeface="Times New Roman"/>
                <a:cs typeface="Times New Roman"/>
              </a:rPr>
              <a:t>a</a:t>
            </a:r>
            <a:r>
              <a:rPr lang="en-US" dirty="0">
                <a:latin typeface="Times New Roman"/>
                <a:cs typeface="Times New Roman"/>
              </a:rPr>
              <a:t>) DBH-AS1; (</a:t>
            </a:r>
            <a:r>
              <a:rPr lang="en-US" b="1" dirty="0">
                <a:latin typeface="Times New Roman"/>
                <a:cs typeface="Times New Roman"/>
              </a:rPr>
              <a:t>b</a:t>
            </a:r>
            <a:r>
              <a:rPr lang="en-US" dirty="0">
                <a:latin typeface="Times New Roman"/>
                <a:cs typeface="Times New Roman"/>
              </a:rPr>
              <a:t>) </a:t>
            </a:r>
            <a:r>
              <a:rPr lang="en-US" dirty="0" err="1">
                <a:latin typeface="Times New Roman"/>
                <a:cs typeface="Times New Roman"/>
              </a:rPr>
              <a:t>hDREH</a:t>
            </a:r>
            <a:r>
              <a:rPr lang="en-US" dirty="0">
                <a:latin typeface="Times New Roman"/>
                <a:cs typeface="Times New Roman"/>
              </a:rPr>
              <a:t>; (</a:t>
            </a:r>
            <a:r>
              <a:rPr lang="en-US" b="1" dirty="0">
                <a:latin typeface="Times New Roman"/>
                <a:cs typeface="Times New Roman"/>
              </a:rPr>
              <a:t>c</a:t>
            </a:r>
            <a:r>
              <a:rPr lang="en-US" dirty="0">
                <a:latin typeface="Times New Roman"/>
                <a:cs typeface="Times New Roman"/>
              </a:rPr>
              <a:t>) hPVT1. </a:t>
            </a:r>
            <a:r>
              <a:rPr lang="en-US" b="1" dirty="0" smtClean="0">
                <a:latin typeface="Times New Roman"/>
                <a:cs typeface="Times New Roman"/>
              </a:rPr>
              <a:t> 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93306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70</TotalTime>
  <Words>119</Words>
  <Application>Microsoft Office PowerPoint</Application>
  <PresentationFormat>全屏显示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D</dc:creator>
  <cp:lastModifiedBy>Ting</cp:lastModifiedBy>
  <cp:revision>107</cp:revision>
  <cp:lastPrinted>2016-04-18T18:57:51Z</cp:lastPrinted>
  <dcterms:created xsi:type="dcterms:W3CDTF">2013-01-08T10:33:48Z</dcterms:created>
  <dcterms:modified xsi:type="dcterms:W3CDTF">2016-10-21T01:15:57Z</dcterms:modified>
</cp:coreProperties>
</file>